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60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3" autoAdjust="0"/>
    <p:restoredTop sz="94660"/>
  </p:normalViewPr>
  <p:slideViewPr>
    <p:cSldViewPr snapToGrid="0">
      <p:cViewPr varScale="1">
        <p:scale>
          <a:sx n="76" d="100"/>
          <a:sy n="76" d="100"/>
        </p:scale>
        <p:origin x="71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73CDF-5D1D-465A-A104-15120D0063FA}" type="datetimeFigureOut">
              <a:rPr kumimoji="1" lang="ja-JP" altLang="en-US" smtClean="0"/>
              <a:t>2020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69F2E-6399-448D-A49A-0E7B887896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3384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73CDF-5D1D-465A-A104-15120D0063FA}" type="datetimeFigureOut">
              <a:rPr kumimoji="1" lang="ja-JP" altLang="en-US" smtClean="0"/>
              <a:t>2020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69F2E-6399-448D-A49A-0E7B887896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3489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73CDF-5D1D-465A-A104-15120D0063FA}" type="datetimeFigureOut">
              <a:rPr kumimoji="1" lang="ja-JP" altLang="en-US" smtClean="0"/>
              <a:t>2020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69F2E-6399-448D-A49A-0E7B887896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2064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73CDF-5D1D-465A-A104-15120D0063FA}" type="datetimeFigureOut">
              <a:rPr kumimoji="1" lang="ja-JP" altLang="en-US" smtClean="0"/>
              <a:t>2020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69F2E-6399-448D-A49A-0E7B887896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0535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73CDF-5D1D-465A-A104-15120D0063FA}" type="datetimeFigureOut">
              <a:rPr kumimoji="1" lang="ja-JP" altLang="en-US" smtClean="0"/>
              <a:t>2020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69F2E-6399-448D-A49A-0E7B887896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25416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73CDF-5D1D-465A-A104-15120D0063FA}" type="datetimeFigureOut">
              <a:rPr kumimoji="1" lang="ja-JP" altLang="en-US" smtClean="0"/>
              <a:t>2020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69F2E-6399-448D-A49A-0E7B887896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3309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73CDF-5D1D-465A-A104-15120D0063FA}" type="datetimeFigureOut">
              <a:rPr kumimoji="1" lang="ja-JP" altLang="en-US" smtClean="0"/>
              <a:t>2020/10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69F2E-6399-448D-A49A-0E7B887896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7564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73CDF-5D1D-465A-A104-15120D0063FA}" type="datetimeFigureOut">
              <a:rPr kumimoji="1" lang="ja-JP" altLang="en-US" smtClean="0"/>
              <a:t>2020/10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69F2E-6399-448D-A49A-0E7B887896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3728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73CDF-5D1D-465A-A104-15120D0063FA}" type="datetimeFigureOut">
              <a:rPr kumimoji="1" lang="ja-JP" altLang="en-US" smtClean="0"/>
              <a:t>2020/10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69F2E-6399-448D-A49A-0E7B887896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9508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73CDF-5D1D-465A-A104-15120D0063FA}" type="datetimeFigureOut">
              <a:rPr kumimoji="1" lang="ja-JP" altLang="en-US" smtClean="0"/>
              <a:t>2020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69F2E-6399-448D-A49A-0E7B887896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1419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73CDF-5D1D-465A-A104-15120D0063FA}" type="datetimeFigureOut">
              <a:rPr kumimoji="1" lang="ja-JP" altLang="en-US" smtClean="0"/>
              <a:t>2020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69F2E-6399-448D-A49A-0E7B887896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51461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73CDF-5D1D-465A-A104-15120D0063FA}" type="datetimeFigureOut">
              <a:rPr kumimoji="1" lang="ja-JP" altLang="en-US" smtClean="0"/>
              <a:t>2020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369F2E-6399-448D-A49A-0E7B887896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3106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図 25" descr="グラフ, 折れ線グラフ&#10;&#10;自動的に生成された説明">
            <a:extLst>
              <a:ext uri="{FF2B5EF4-FFF2-40B4-BE49-F238E27FC236}">
                <a16:creationId xmlns:a16="http://schemas.microsoft.com/office/drawing/2014/main" id="{5D011D4C-0852-4480-A35B-8DB2A27D06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863" y="595784"/>
            <a:ext cx="9088942" cy="5448317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EB8BF65-B580-4F7B-9F9D-45789F88B9BF}"/>
              </a:ext>
            </a:extLst>
          </p:cNvPr>
          <p:cNvSpPr txBox="1"/>
          <p:nvPr/>
        </p:nvSpPr>
        <p:spPr>
          <a:xfrm>
            <a:off x="1358232" y="5939050"/>
            <a:ext cx="71987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SM. 4_1. (a) atmospheric pressure, (b) presence of rainfall, (c) amount of rainfall per hour, (d) salinity,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d (e) water temperature 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from 9:00 AM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n 12th August 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to 4:00 PM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n 15th August. 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 indicates rain presence and 1 indicates rain absence.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298EA0A-315E-4145-AB93-224F8FEADFA1}"/>
              </a:ext>
            </a:extLst>
          </p:cNvPr>
          <p:cNvSpPr txBox="1"/>
          <p:nvPr/>
        </p:nvSpPr>
        <p:spPr>
          <a:xfrm rot="16200000">
            <a:off x="-350162" y="829690"/>
            <a:ext cx="102944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tmospheric 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ressure (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hPa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5403B3F-A562-4F19-90A7-062D998B2986}"/>
              </a:ext>
            </a:extLst>
          </p:cNvPr>
          <p:cNvSpPr txBox="1"/>
          <p:nvPr/>
        </p:nvSpPr>
        <p:spPr>
          <a:xfrm rot="16200000">
            <a:off x="-62090" y="1988301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ainfal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4862225-7004-4913-A367-773A71E2A323}"/>
              </a:ext>
            </a:extLst>
          </p:cNvPr>
          <p:cNvSpPr txBox="1"/>
          <p:nvPr/>
        </p:nvSpPr>
        <p:spPr>
          <a:xfrm rot="16200000">
            <a:off x="-250561" y="2788349"/>
            <a:ext cx="9476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ainfall (mm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1DD5A93-773F-4364-92EF-C53FBD18B998}"/>
              </a:ext>
            </a:extLst>
          </p:cNvPr>
          <p:cNvSpPr txBox="1"/>
          <p:nvPr/>
        </p:nvSpPr>
        <p:spPr>
          <a:xfrm rot="16200000">
            <a:off x="-71654" y="3803138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alinity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D441853-0B37-458F-AC11-0A304FE7977A}"/>
              </a:ext>
            </a:extLst>
          </p:cNvPr>
          <p:cNvSpPr txBox="1"/>
          <p:nvPr/>
        </p:nvSpPr>
        <p:spPr>
          <a:xfrm rot="16200000">
            <a:off x="-385040" y="4699419"/>
            <a:ext cx="11256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 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emperature (</a:t>
            </a:r>
            <a:r>
              <a: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6E16960-C1BB-48BC-A5B4-8DBFBCE6021F}"/>
              </a:ext>
            </a:extLst>
          </p:cNvPr>
          <p:cNvSpPr txBox="1"/>
          <p:nvPr/>
        </p:nvSpPr>
        <p:spPr>
          <a:xfrm>
            <a:off x="790731" y="674413"/>
            <a:ext cx="2760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86F44E1-28C3-4A61-B33C-93D4368FF9DD}"/>
              </a:ext>
            </a:extLst>
          </p:cNvPr>
          <p:cNvSpPr txBox="1"/>
          <p:nvPr/>
        </p:nvSpPr>
        <p:spPr>
          <a:xfrm>
            <a:off x="790731" y="1655411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9AB689B-9E4C-480C-8399-4A4AB833A376}"/>
              </a:ext>
            </a:extLst>
          </p:cNvPr>
          <p:cNvSpPr txBox="1"/>
          <p:nvPr/>
        </p:nvSpPr>
        <p:spPr>
          <a:xfrm>
            <a:off x="801951" y="3436692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A3ABC50-777F-470D-9F2A-C4DB615C675C}"/>
              </a:ext>
            </a:extLst>
          </p:cNvPr>
          <p:cNvSpPr txBox="1"/>
          <p:nvPr/>
        </p:nvSpPr>
        <p:spPr>
          <a:xfrm>
            <a:off x="801951" y="4361826"/>
            <a:ext cx="2760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DBB5E06-2383-4A47-B9B9-581D97616F20}"/>
              </a:ext>
            </a:extLst>
          </p:cNvPr>
          <p:cNvSpPr txBox="1"/>
          <p:nvPr/>
        </p:nvSpPr>
        <p:spPr>
          <a:xfrm>
            <a:off x="790731" y="2471007"/>
            <a:ext cx="2760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59784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 descr="グラフ が含まれている画像&#10;&#10;自動的に生成された説明">
            <a:extLst>
              <a:ext uri="{FF2B5EF4-FFF2-40B4-BE49-F238E27FC236}">
                <a16:creationId xmlns:a16="http://schemas.microsoft.com/office/drawing/2014/main" id="{9D089B24-4A1D-4166-B9E0-B1188FA300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29" y="704841"/>
            <a:ext cx="9088942" cy="5448317"/>
          </a:xfrm>
          <a:prstGeom prst="rect">
            <a:avLst/>
          </a:prstGeom>
        </p:spPr>
      </p:pic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572A95CF-7357-42FA-8193-BBA44020FEE5}"/>
              </a:ext>
            </a:extLst>
          </p:cNvPr>
          <p:cNvSpPr txBox="1"/>
          <p:nvPr/>
        </p:nvSpPr>
        <p:spPr>
          <a:xfrm>
            <a:off x="557171" y="6237596"/>
            <a:ext cx="7285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SM. 4_2. (a) atmospheric pressure, (b) presence of rainfall, (c) amount of rainfall per hour, (d) salinity,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d (e) water temperature from 9:00 AM on 3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eptember to 4:00 AM on 10th September. 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 indicates rain presence and 1 indicates rain absence.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83BC8BB-883E-48C3-A0E0-C50D14E0A417}"/>
              </a:ext>
            </a:extLst>
          </p:cNvPr>
          <p:cNvSpPr txBox="1"/>
          <p:nvPr/>
        </p:nvSpPr>
        <p:spPr>
          <a:xfrm>
            <a:off x="8081940" y="3640333"/>
            <a:ext cx="7681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/>
              <a:t>ID4 spawning </a:t>
            </a:r>
          </a:p>
          <a:p>
            <a:pPr algn="ctr"/>
            <a:r>
              <a:rPr kumimoji="1" lang="ja-JP" altLang="en-US" sz="800" dirty="0"/>
              <a:t>↓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C9CAB17-92D4-4EE0-9959-7BD76DE26BB6}"/>
              </a:ext>
            </a:extLst>
          </p:cNvPr>
          <p:cNvSpPr txBox="1"/>
          <p:nvPr/>
        </p:nvSpPr>
        <p:spPr>
          <a:xfrm>
            <a:off x="3875610" y="4123941"/>
            <a:ext cx="768159" cy="215444"/>
          </a:xfrm>
          <a:prstGeom prst="rect">
            <a:avLst/>
          </a:prstGeom>
          <a:solidFill>
            <a:schemeClr val="bg1">
              <a:alpha val="60000"/>
            </a:schemeClr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ID3 spawning 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B8E513B-2E19-4F98-9EE4-0DFC1E3495AF}"/>
              </a:ext>
            </a:extLst>
          </p:cNvPr>
          <p:cNvSpPr txBox="1"/>
          <p:nvPr/>
        </p:nvSpPr>
        <p:spPr>
          <a:xfrm rot="16200000">
            <a:off x="-366940" y="1005860"/>
            <a:ext cx="102944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tmospheric 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ressure (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hPa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13BC36C-1EE5-4406-B53F-2DC8B75661A5}"/>
              </a:ext>
            </a:extLst>
          </p:cNvPr>
          <p:cNvSpPr txBox="1"/>
          <p:nvPr/>
        </p:nvSpPr>
        <p:spPr>
          <a:xfrm rot="16200000">
            <a:off x="-62090" y="2097358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ainfal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4E51498-01BC-4B34-BFBD-8EF47E8ABDFC}"/>
              </a:ext>
            </a:extLst>
          </p:cNvPr>
          <p:cNvSpPr txBox="1"/>
          <p:nvPr/>
        </p:nvSpPr>
        <p:spPr>
          <a:xfrm rot="16200000">
            <a:off x="-242172" y="2964518"/>
            <a:ext cx="9476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ainfall (mm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D3D432F-A76A-44A5-BAB4-EC527F736DC1}"/>
              </a:ext>
            </a:extLst>
          </p:cNvPr>
          <p:cNvSpPr txBox="1"/>
          <p:nvPr/>
        </p:nvSpPr>
        <p:spPr>
          <a:xfrm rot="16200000">
            <a:off x="-71654" y="3979307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alinity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1A23366-A822-4377-A8A0-3EC84683FF76}"/>
              </a:ext>
            </a:extLst>
          </p:cNvPr>
          <p:cNvSpPr txBox="1"/>
          <p:nvPr/>
        </p:nvSpPr>
        <p:spPr>
          <a:xfrm rot="16200000">
            <a:off x="-410206" y="4825255"/>
            <a:ext cx="11256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 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emperature (</a:t>
            </a:r>
            <a:r>
              <a: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5CCA137-2595-427C-97C7-DB80C45B9A4E}"/>
              </a:ext>
            </a:extLst>
          </p:cNvPr>
          <p:cNvSpPr txBox="1"/>
          <p:nvPr/>
        </p:nvSpPr>
        <p:spPr>
          <a:xfrm>
            <a:off x="790731" y="842193"/>
            <a:ext cx="2760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AC12672-A8D6-488E-ADEE-C4CF47BF5035}"/>
              </a:ext>
            </a:extLst>
          </p:cNvPr>
          <p:cNvSpPr txBox="1"/>
          <p:nvPr/>
        </p:nvSpPr>
        <p:spPr>
          <a:xfrm>
            <a:off x="790731" y="1806413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1A7917E-D4BD-4AEF-AB82-A56F8129177E}"/>
              </a:ext>
            </a:extLst>
          </p:cNvPr>
          <p:cNvSpPr txBox="1"/>
          <p:nvPr/>
        </p:nvSpPr>
        <p:spPr>
          <a:xfrm>
            <a:off x="801951" y="3713529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C45A316-8932-4806-AB0D-E75986B44F9B}"/>
              </a:ext>
            </a:extLst>
          </p:cNvPr>
          <p:cNvSpPr txBox="1"/>
          <p:nvPr/>
        </p:nvSpPr>
        <p:spPr>
          <a:xfrm>
            <a:off x="801951" y="4454105"/>
            <a:ext cx="2760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E79ED23-973D-4EDD-9331-A0363A72C0E9}"/>
              </a:ext>
            </a:extLst>
          </p:cNvPr>
          <p:cNvSpPr txBox="1"/>
          <p:nvPr/>
        </p:nvSpPr>
        <p:spPr>
          <a:xfrm>
            <a:off x="790731" y="2554897"/>
            <a:ext cx="2760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8DE3F1B0-B5D2-4219-B727-09E6A986FA18}"/>
              </a:ext>
            </a:extLst>
          </p:cNvPr>
          <p:cNvCxnSpPr>
            <a:cxnSpLocks/>
          </p:cNvCxnSpPr>
          <p:nvPr/>
        </p:nvCxnSpPr>
        <p:spPr>
          <a:xfrm flipV="1">
            <a:off x="4368202" y="3804098"/>
            <a:ext cx="0" cy="370649"/>
          </a:xfrm>
          <a:prstGeom prst="straightConnector1">
            <a:avLst/>
          </a:prstGeom>
          <a:ln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53135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9</Words>
  <Application>Microsoft Office PowerPoint</Application>
  <PresentationFormat>画面に合わせる (4:3)</PresentationFormat>
  <Paragraphs>3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0-10-26T08:09:24Z</dcterms:created>
  <dcterms:modified xsi:type="dcterms:W3CDTF">2020-10-26T08:09:27Z</dcterms:modified>
</cp:coreProperties>
</file>